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19931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05" autoAdjust="0"/>
    <p:restoredTop sz="89247" autoAdjust="0"/>
  </p:normalViewPr>
  <p:slideViewPr>
    <p:cSldViewPr snapToGrid="0">
      <p:cViewPr varScale="1">
        <p:scale>
          <a:sx n="69" d="100"/>
          <a:sy n="69" d="100"/>
        </p:scale>
        <p:origin x="4000" y="192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359AD5-3FD2-4334-AA43-651A615B5D64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07AF3E-E226-44AD-A662-4E32329D5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2708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07AF3E-E226-44AD-A662-4E32329D5F7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270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767462"/>
            <a:ext cx="6119416" cy="375991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5672376"/>
            <a:ext cx="5399485" cy="2607442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151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012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574987"/>
            <a:ext cx="1552352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574987"/>
            <a:ext cx="4567064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387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5057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692444"/>
            <a:ext cx="6209407" cy="4492401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7227345"/>
            <a:ext cx="6209407" cy="236244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993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58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574990"/>
            <a:ext cx="6209407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647443"/>
            <a:ext cx="3045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3944914"/>
            <a:ext cx="3045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647443"/>
            <a:ext cx="3060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3944914"/>
            <a:ext cx="3060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079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1655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837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554968"/>
            <a:ext cx="3644652" cy="767483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671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554968"/>
            <a:ext cx="3644652" cy="767483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148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574990"/>
            <a:ext cx="6209407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874937"/>
            <a:ext cx="6209407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0009783"/>
            <a:ext cx="242976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392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kumimoji="1"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FAAECB7-0CFF-5772-9DC6-CA5BCF5CE4B3}"/>
              </a:ext>
            </a:extLst>
          </p:cNvPr>
          <p:cNvSpPr txBox="1"/>
          <p:nvPr/>
        </p:nvSpPr>
        <p:spPr>
          <a:xfrm>
            <a:off x="364671" y="275550"/>
            <a:ext cx="662510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</a:t>
            </a:r>
            <a:r>
              <a:rPr lang="en-US" altLang="ja-JP" b="1" kern="10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able</a:t>
            </a:r>
            <a:r>
              <a:rPr lang="en-US" altLang="ja-JP" sz="1800" b="1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2. </a:t>
            </a:r>
          </a:p>
          <a:p>
            <a:pPr algn="just"/>
            <a:r>
              <a:rPr lang="en-US" altLang="ja-JP" sz="1800" kern="10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ategory of the patient’s annual income in 2019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09B8434E-0CCB-743E-0AEC-980D88AD0E15}"/>
              </a:ext>
            </a:extLst>
          </p:cNvPr>
          <p:cNvGrpSpPr/>
          <p:nvPr/>
        </p:nvGrpSpPr>
        <p:grpSpPr>
          <a:xfrm>
            <a:off x="131567" y="1000530"/>
            <a:ext cx="6881025" cy="2767071"/>
            <a:chOff x="337614" y="1188043"/>
            <a:chExt cx="6412260" cy="2480355"/>
          </a:xfrm>
        </p:grpSpPr>
        <p:sp>
          <p:nvSpPr>
            <p:cNvPr id="84" name="フリーフォーム: 図形 83">
              <a:extLst>
                <a:ext uri="{FF2B5EF4-FFF2-40B4-BE49-F238E27FC236}">
                  <a16:creationId xmlns:a16="http://schemas.microsoft.com/office/drawing/2014/main" id="{F6C0E69B-5E6E-5526-12F8-ED670F906BBE}"/>
                </a:ext>
              </a:extLst>
            </p:cNvPr>
            <p:cNvSpPr/>
            <p:nvPr/>
          </p:nvSpPr>
          <p:spPr>
            <a:xfrm>
              <a:off x="337614" y="1188043"/>
              <a:ext cx="6390996" cy="2480355"/>
            </a:xfrm>
            <a:custGeom>
              <a:avLst/>
              <a:gdLst>
                <a:gd name="connsiteX0" fmla="*/ 0 w 6524082"/>
                <a:gd name="connsiteY0" fmla="*/ 0 h 488935"/>
                <a:gd name="connsiteX1" fmla="*/ 6524083 w 6524082"/>
                <a:gd name="connsiteY1" fmla="*/ 0 h 488935"/>
                <a:gd name="connsiteX2" fmla="*/ 6524083 w 6524082"/>
                <a:gd name="connsiteY2" fmla="*/ 488936 h 488935"/>
                <a:gd name="connsiteX3" fmla="*/ 0 w 6524082"/>
                <a:gd name="connsiteY3" fmla="*/ 488936 h 4889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524082" h="488935">
                  <a:moveTo>
                    <a:pt x="0" y="0"/>
                  </a:moveTo>
                  <a:lnTo>
                    <a:pt x="6524083" y="0"/>
                  </a:lnTo>
                  <a:lnTo>
                    <a:pt x="6524083" y="488936"/>
                  </a:lnTo>
                  <a:lnTo>
                    <a:pt x="0" y="488936"/>
                  </a:lnTo>
                  <a:close/>
                </a:path>
              </a:pathLst>
            </a:custGeom>
            <a:noFill/>
            <a:ln w="7015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15909ED3-88CF-FDBF-1121-03EDFD474BD7}"/>
                </a:ext>
              </a:extLst>
            </p:cNvPr>
            <p:cNvSpPr txBox="1"/>
            <p:nvPr/>
          </p:nvSpPr>
          <p:spPr>
            <a:xfrm>
              <a:off x="385935" y="1206185"/>
              <a:ext cx="6363939" cy="2268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endPara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478C361-302B-7184-A7C7-BCB935AB714B}"/>
              </a:ext>
            </a:extLst>
          </p:cNvPr>
          <p:cNvSpPr txBox="1"/>
          <p:nvPr/>
        </p:nvSpPr>
        <p:spPr>
          <a:xfrm>
            <a:off x="131567" y="1014320"/>
            <a:ext cx="6806354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ctual answer of the patient) = (annual income of the patient that is assumed)</a:t>
            </a:r>
          </a:p>
          <a:p>
            <a:pPr algn="just"/>
            <a:endParaRPr lang="en-US" altLang="ja-JP" sz="14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No income” = 0 yen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less than 1 million yen” = 500,000 yen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less than 1 million to 2 million yen” = 1,500,000 yen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2 million to less than 4 million yen” = 3,000,000 yen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4–6 million yen” = 5,000,000 yen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less than 6–8 million yen” = 7,000,000 yen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8–10 million yen” = 9,000,000 yen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less than 10–12 million yen” = 11,000,000 yen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“Annual income less than 12–14 million yen” = 13,000,000 yen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“Annual income of 14 million yen or more” = 16,000,000 yen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745372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58</TotalTime>
  <Words>150</Words>
  <Application>Microsoft Macintosh PowerPoint</Application>
  <PresentationFormat>ユーザー設定</PresentationFormat>
  <Paragraphs>1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正木 克宜</dc:creator>
  <cp:lastModifiedBy>Katsunori Masaki</cp:lastModifiedBy>
  <cp:revision>8</cp:revision>
  <dcterms:created xsi:type="dcterms:W3CDTF">2024-03-15T15:51:48Z</dcterms:created>
  <dcterms:modified xsi:type="dcterms:W3CDTF">2024-09-23T15:12:05Z</dcterms:modified>
</cp:coreProperties>
</file>